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1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88" userDrawn="1">
          <p15:clr>
            <a:srgbClr val="A4A3A4"/>
          </p15:clr>
        </p15:guide>
        <p15:guide id="2" pos="10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364" autoAdjust="0"/>
  </p:normalViewPr>
  <p:slideViewPr>
    <p:cSldViewPr>
      <p:cViewPr varScale="1">
        <p:scale>
          <a:sx n="51" d="100"/>
          <a:sy n="51" d="100"/>
        </p:scale>
        <p:origin x="2316" y="90"/>
      </p:cViewPr>
      <p:guideLst>
        <p:guide orient="horz" pos="988"/>
        <p:guide pos="102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3AB5B-17B4-40CD-BC33-E8D1BD8B6E06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09B63D-3E21-4754-A574-5B91CFC8220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018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78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560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34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12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90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681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462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24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1558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1pPr>
            <a:lvl2pPr marL="178030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2pPr>
            <a:lvl3pPr marL="356059" indent="0">
              <a:buNone/>
              <a:defRPr sz="623">
                <a:solidFill>
                  <a:schemeClr val="tx1">
                    <a:tint val="75000"/>
                  </a:schemeClr>
                </a:solidFill>
              </a:defRPr>
            </a:lvl3pPr>
            <a:lvl4pPr marL="534088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4pPr>
            <a:lvl5pPr marL="712117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5pPr>
            <a:lvl6pPr marL="890146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6pPr>
            <a:lvl7pPr marL="1068175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7pPr>
            <a:lvl8pPr marL="1246205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8pPr>
            <a:lvl9pPr marL="1424234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1090"/>
            </a:lvl1pPr>
            <a:lvl2pPr>
              <a:defRPr sz="935"/>
            </a:lvl2pPr>
            <a:lvl3pPr>
              <a:defRPr sz="779"/>
            </a:lvl3pPr>
            <a:lvl4pPr>
              <a:defRPr sz="701"/>
            </a:lvl4pPr>
            <a:lvl5pPr>
              <a:defRPr sz="701"/>
            </a:lvl5pPr>
            <a:lvl6pPr>
              <a:defRPr sz="701"/>
            </a:lvl6pPr>
            <a:lvl7pPr>
              <a:defRPr sz="701"/>
            </a:lvl7pPr>
            <a:lvl8pPr>
              <a:defRPr sz="701"/>
            </a:lvl8pPr>
            <a:lvl9pPr>
              <a:defRPr sz="7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1090"/>
            </a:lvl1pPr>
            <a:lvl2pPr>
              <a:defRPr sz="935"/>
            </a:lvl2pPr>
            <a:lvl3pPr>
              <a:defRPr sz="779"/>
            </a:lvl3pPr>
            <a:lvl4pPr>
              <a:defRPr sz="701"/>
            </a:lvl4pPr>
            <a:lvl5pPr>
              <a:defRPr sz="701"/>
            </a:lvl5pPr>
            <a:lvl6pPr>
              <a:defRPr sz="701"/>
            </a:lvl6pPr>
            <a:lvl7pPr>
              <a:defRPr sz="701"/>
            </a:lvl7pPr>
            <a:lvl8pPr>
              <a:defRPr sz="701"/>
            </a:lvl8pPr>
            <a:lvl9pPr>
              <a:defRPr sz="7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2" y="2217387"/>
            <a:ext cx="3030141" cy="924101"/>
          </a:xfrm>
        </p:spPr>
        <p:txBody>
          <a:bodyPr anchor="b"/>
          <a:lstStyle>
            <a:lvl1pPr marL="0" indent="0">
              <a:buNone/>
              <a:defRPr sz="935" b="1"/>
            </a:lvl1pPr>
            <a:lvl2pPr marL="178030" indent="0">
              <a:buNone/>
              <a:defRPr sz="779" b="1"/>
            </a:lvl2pPr>
            <a:lvl3pPr marL="356059" indent="0">
              <a:buNone/>
              <a:defRPr sz="701" b="1"/>
            </a:lvl3pPr>
            <a:lvl4pPr marL="534088" indent="0">
              <a:buNone/>
              <a:defRPr sz="623" b="1"/>
            </a:lvl4pPr>
            <a:lvl5pPr marL="712117" indent="0">
              <a:buNone/>
              <a:defRPr sz="623" b="1"/>
            </a:lvl5pPr>
            <a:lvl6pPr marL="890146" indent="0">
              <a:buNone/>
              <a:defRPr sz="623" b="1"/>
            </a:lvl6pPr>
            <a:lvl7pPr marL="1068175" indent="0">
              <a:buNone/>
              <a:defRPr sz="623" b="1"/>
            </a:lvl7pPr>
            <a:lvl8pPr marL="1246205" indent="0">
              <a:buNone/>
              <a:defRPr sz="623" b="1"/>
            </a:lvl8pPr>
            <a:lvl9pPr marL="1424234" indent="0">
              <a:buNone/>
              <a:defRPr sz="62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935"/>
            </a:lvl1pPr>
            <a:lvl2pPr>
              <a:defRPr sz="779"/>
            </a:lvl2pPr>
            <a:lvl3pPr>
              <a:defRPr sz="701"/>
            </a:lvl3pPr>
            <a:lvl4pPr>
              <a:defRPr sz="623"/>
            </a:lvl4pPr>
            <a:lvl5pPr>
              <a:defRPr sz="623"/>
            </a:lvl5pPr>
            <a:lvl6pPr>
              <a:defRPr sz="623"/>
            </a:lvl6pPr>
            <a:lvl7pPr>
              <a:defRPr sz="623"/>
            </a:lvl7pPr>
            <a:lvl8pPr>
              <a:defRPr sz="623"/>
            </a:lvl8pPr>
            <a:lvl9pPr>
              <a:defRPr sz="62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7"/>
            <a:ext cx="3031331" cy="924101"/>
          </a:xfrm>
        </p:spPr>
        <p:txBody>
          <a:bodyPr anchor="b"/>
          <a:lstStyle>
            <a:lvl1pPr marL="0" indent="0">
              <a:buNone/>
              <a:defRPr sz="935" b="1"/>
            </a:lvl1pPr>
            <a:lvl2pPr marL="178030" indent="0">
              <a:buNone/>
              <a:defRPr sz="779" b="1"/>
            </a:lvl2pPr>
            <a:lvl3pPr marL="356059" indent="0">
              <a:buNone/>
              <a:defRPr sz="701" b="1"/>
            </a:lvl3pPr>
            <a:lvl4pPr marL="534088" indent="0">
              <a:buNone/>
              <a:defRPr sz="623" b="1"/>
            </a:lvl4pPr>
            <a:lvl5pPr marL="712117" indent="0">
              <a:buNone/>
              <a:defRPr sz="623" b="1"/>
            </a:lvl5pPr>
            <a:lvl6pPr marL="890146" indent="0">
              <a:buNone/>
              <a:defRPr sz="623" b="1"/>
            </a:lvl6pPr>
            <a:lvl7pPr marL="1068175" indent="0">
              <a:buNone/>
              <a:defRPr sz="623" b="1"/>
            </a:lvl7pPr>
            <a:lvl8pPr marL="1246205" indent="0">
              <a:buNone/>
              <a:defRPr sz="623" b="1"/>
            </a:lvl8pPr>
            <a:lvl9pPr marL="1424234" indent="0">
              <a:buNone/>
              <a:defRPr sz="62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935"/>
            </a:lvl1pPr>
            <a:lvl2pPr>
              <a:defRPr sz="779"/>
            </a:lvl2pPr>
            <a:lvl3pPr>
              <a:defRPr sz="701"/>
            </a:lvl3pPr>
            <a:lvl4pPr>
              <a:defRPr sz="623"/>
            </a:lvl4pPr>
            <a:lvl5pPr>
              <a:defRPr sz="623"/>
            </a:lvl5pPr>
            <a:lvl6pPr>
              <a:defRPr sz="623"/>
            </a:lvl6pPr>
            <a:lvl7pPr>
              <a:defRPr sz="623"/>
            </a:lvl7pPr>
            <a:lvl8pPr>
              <a:defRPr sz="623"/>
            </a:lvl8pPr>
            <a:lvl9pPr>
              <a:defRPr sz="62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94407"/>
            <a:ext cx="2256235" cy="1678517"/>
          </a:xfrm>
        </p:spPr>
        <p:txBody>
          <a:bodyPr anchor="b"/>
          <a:lstStyle>
            <a:lvl1pPr algn="l">
              <a:defRPr sz="779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9" y="394410"/>
            <a:ext cx="3833813" cy="8454497"/>
          </a:xfrm>
        </p:spPr>
        <p:txBody>
          <a:bodyPr/>
          <a:lstStyle>
            <a:lvl1pPr>
              <a:defRPr sz="1246"/>
            </a:lvl1pPr>
            <a:lvl2pPr>
              <a:defRPr sz="1090"/>
            </a:lvl2pPr>
            <a:lvl3pPr>
              <a:defRPr sz="935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545"/>
            </a:lvl1pPr>
            <a:lvl2pPr marL="178030" indent="0">
              <a:buNone/>
              <a:defRPr sz="467"/>
            </a:lvl2pPr>
            <a:lvl3pPr marL="356059" indent="0">
              <a:buNone/>
              <a:defRPr sz="389"/>
            </a:lvl3pPr>
            <a:lvl4pPr marL="534088" indent="0">
              <a:buNone/>
              <a:defRPr sz="350"/>
            </a:lvl4pPr>
            <a:lvl5pPr marL="712117" indent="0">
              <a:buNone/>
              <a:defRPr sz="350"/>
            </a:lvl5pPr>
            <a:lvl6pPr marL="890146" indent="0">
              <a:buNone/>
              <a:defRPr sz="350"/>
            </a:lvl6pPr>
            <a:lvl7pPr marL="1068175" indent="0">
              <a:buNone/>
              <a:defRPr sz="350"/>
            </a:lvl7pPr>
            <a:lvl8pPr marL="1246205" indent="0">
              <a:buNone/>
              <a:defRPr sz="350"/>
            </a:lvl8pPr>
            <a:lvl9pPr marL="1424234" indent="0">
              <a:buNone/>
              <a:defRPr sz="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779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1246"/>
            </a:lvl1pPr>
            <a:lvl2pPr marL="178030" indent="0">
              <a:buNone/>
              <a:defRPr sz="1090"/>
            </a:lvl2pPr>
            <a:lvl3pPr marL="356059" indent="0">
              <a:buNone/>
              <a:defRPr sz="935"/>
            </a:lvl3pPr>
            <a:lvl4pPr marL="534088" indent="0">
              <a:buNone/>
              <a:defRPr sz="779"/>
            </a:lvl4pPr>
            <a:lvl5pPr marL="712117" indent="0">
              <a:buNone/>
              <a:defRPr sz="779"/>
            </a:lvl5pPr>
            <a:lvl6pPr marL="890146" indent="0">
              <a:buNone/>
              <a:defRPr sz="779"/>
            </a:lvl6pPr>
            <a:lvl7pPr marL="1068175" indent="0">
              <a:buNone/>
              <a:defRPr sz="779"/>
            </a:lvl7pPr>
            <a:lvl8pPr marL="1246205" indent="0">
              <a:buNone/>
              <a:defRPr sz="779"/>
            </a:lvl8pPr>
            <a:lvl9pPr marL="1424234" indent="0">
              <a:buNone/>
              <a:defRPr sz="779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545"/>
            </a:lvl1pPr>
            <a:lvl2pPr marL="178030" indent="0">
              <a:buNone/>
              <a:defRPr sz="467"/>
            </a:lvl2pPr>
            <a:lvl3pPr marL="356059" indent="0">
              <a:buNone/>
              <a:defRPr sz="389"/>
            </a:lvl3pPr>
            <a:lvl4pPr marL="534088" indent="0">
              <a:buNone/>
              <a:defRPr sz="350"/>
            </a:lvl4pPr>
            <a:lvl5pPr marL="712117" indent="0">
              <a:buNone/>
              <a:defRPr sz="350"/>
            </a:lvl5pPr>
            <a:lvl6pPr marL="890146" indent="0">
              <a:buNone/>
              <a:defRPr sz="350"/>
            </a:lvl6pPr>
            <a:lvl7pPr marL="1068175" indent="0">
              <a:buNone/>
              <a:defRPr sz="350"/>
            </a:lvl7pPr>
            <a:lvl8pPr marL="1246205" indent="0">
              <a:buNone/>
              <a:defRPr sz="350"/>
            </a:lvl8pPr>
            <a:lvl9pPr marL="1424234" indent="0">
              <a:buNone/>
              <a:defRPr sz="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1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56059" rtl="0" eaLnBrk="1" latinLnBrk="0" hangingPunct="1">
        <a:spcBef>
          <a:spcPct val="0"/>
        </a:spcBef>
        <a:buNone/>
        <a:defRPr sz="17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3522" indent="-133522" algn="l" defTabSz="356059" rtl="0" eaLnBrk="1" latinLnBrk="0" hangingPunct="1">
        <a:spcBef>
          <a:spcPct val="20000"/>
        </a:spcBef>
        <a:buFont typeface="Arial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289298" indent="-111269" algn="l" defTabSz="356059" rtl="0" eaLnBrk="1" latinLnBrk="0" hangingPunct="1">
        <a:spcBef>
          <a:spcPct val="20000"/>
        </a:spcBef>
        <a:buFont typeface="Arial" pitchFamily="34" charset="0"/>
        <a:buChar char="–"/>
        <a:defRPr sz="1090" kern="1200">
          <a:solidFill>
            <a:schemeClr val="tx1"/>
          </a:solidFill>
          <a:latin typeface="+mn-lt"/>
          <a:ea typeface="+mn-ea"/>
          <a:cs typeface="+mn-cs"/>
        </a:defRPr>
      </a:lvl2pPr>
      <a:lvl3pPr marL="445073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623102" indent="-89015" algn="l" defTabSz="356059" rtl="0" eaLnBrk="1" latinLnBrk="0" hangingPunct="1">
        <a:spcBef>
          <a:spcPct val="20000"/>
        </a:spcBef>
        <a:buFont typeface="Arial" pitchFamily="34" charset="0"/>
        <a:buChar char="–"/>
        <a:defRPr sz="779" kern="1200">
          <a:solidFill>
            <a:schemeClr val="tx1"/>
          </a:solidFill>
          <a:latin typeface="+mn-lt"/>
          <a:ea typeface="+mn-ea"/>
          <a:cs typeface="+mn-cs"/>
        </a:defRPr>
      </a:lvl4pPr>
      <a:lvl5pPr marL="801132" indent="-89015" algn="l" defTabSz="356059" rtl="0" eaLnBrk="1" latinLnBrk="0" hangingPunct="1">
        <a:spcBef>
          <a:spcPct val="20000"/>
        </a:spcBef>
        <a:buFont typeface="Arial" pitchFamily="34" charset="0"/>
        <a:buChar char="»"/>
        <a:defRPr sz="779" kern="1200">
          <a:solidFill>
            <a:schemeClr val="tx1"/>
          </a:solidFill>
          <a:latin typeface="+mn-lt"/>
          <a:ea typeface="+mn-ea"/>
          <a:cs typeface="+mn-cs"/>
        </a:defRPr>
      </a:lvl5pPr>
      <a:lvl6pPr marL="979161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6pPr>
      <a:lvl7pPr marL="1157190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7pPr>
      <a:lvl8pPr marL="1335219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8pPr>
      <a:lvl9pPr marL="1513248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1pPr>
      <a:lvl2pPr marL="178030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2pPr>
      <a:lvl3pPr marL="356059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3pPr>
      <a:lvl4pPr marL="534088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4pPr>
      <a:lvl5pPr marL="712117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5pPr>
      <a:lvl6pPr marL="890146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6pPr>
      <a:lvl7pPr marL="1068175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7pPr>
      <a:lvl8pPr marL="1246205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8pPr>
      <a:lvl9pPr marL="1424234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文本框 74"/>
          <p:cNvSpPr txBox="1"/>
          <p:nvPr/>
        </p:nvSpPr>
        <p:spPr>
          <a:xfrm flipH="1">
            <a:off x="144236" y="1225904"/>
            <a:ext cx="3600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16632" y="128464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/>
          <p:cNvCxnSpPr/>
          <p:nvPr/>
        </p:nvCxnSpPr>
        <p:spPr>
          <a:xfrm>
            <a:off x="5805264" y="2356862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>
            <a:off x="5805264" y="2642737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>
            <a:off x="5805264" y="2956242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/>
          <p:cNvCxnSpPr/>
          <p:nvPr/>
        </p:nvCxnSpPr>
        <p:spPr>
          <a:xfrm>
            <a:off x="5805264" y="3194462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/>
          <p:cNvCxnSpPr/>
          <p:nvPr/>
        </p:nvCxnSpPr>
        <p:spPr>
          <a:xfrm>
            <a:off x="5805264" y="3446629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连接符 103"/>
          <p:cNvCxnSpPr/>
          <p:nvPr/>
        </p:nvCxnSpPr>
        <p:spPr>
          <a:xfrm>
            <a:off x="5805264" y="3711410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/>
          <p:cNvCxnSpPr/>
          <p:nvPr/>
        </p:nvCxnSpPr>
        <p:spPr>
          <a:xfrm>
            <a:off x="5805264" y="4203657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/>
          <p:cNvCxnSpPr/>
          <p:nvPr/>
        </p:nvCxnSpPr>
        <p:spPr>
          <a:xfrm>
            <a:off x="5805264" y="2474382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图片 2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34389" y="2186630"/>
            <a:ext cx="669635" cy="2520000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>
              <a:rot lat="0" lon="10799999" rev="0"/>
            </a:camera>
            <a:lightRig rig="threePt" dir="t"/>
          </a:scene3d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75470" y="2186630"/>
            <a:ext cx="667057" cy="2520000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>
              <a:rot lat="10800000" lon="0" rev="0"/>
            </a:camera>
            <a:lightRig rig="threePt" dir="t"/>
          </a:scene3d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213974" y="2186630"/>
            <a:ext cx="663298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矩形 60"/>
          <p:cNvSpPr/>
          <p:nvPr/>
        </p:nvSpPr>
        <p:spPr>
          <a:xfrm>
            <a:off x="3239347" y="1918663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G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5558554" y="1918663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5295760" y="1900140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4771806" y="1918663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矩形 65"/>
          <p:cNvSpPr/>
          <p:nvPr/>
        </p:nvSpPr>
        <p:spPr>
          <a:xfrm>
            <a:off x="4509012" y="1900140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4070186" y="1918663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3807392" y="1900140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11"/>
          <p:cNvSpPr txBox="1"/>
          <p:nvPr/>
        </p:nvSpPr>
        <p:spPr>
          <a:xfrm rot="19500000">
            <a:off x="3862984" y="1484242"/>
            <a:ext cx="115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rg)</a:t>
            </a:r>
            <a:r>
              <a:rPr lang="en-US" altLang="zh-CN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 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2"/>
          <p:cNvSpPr txBox="1"/>
          <p:nvPr/>
        </p:nvSpPr>
        <p:spPr>
          <a:xfrm rot="19500000">
            <a:off x="4514279" y="1290300"/>
            <a:ext cx="1795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rg)</a:t>
            </a:r>
            <a:r>
              <a:rPr lang="en-US" altLang="zh-CN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W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13"/>
          <p:cNvSpPr txBox="1"/>
          <p:nvPr/>
        </p:nvSpPr>
        <p:spPr>
          <a:xfrm rot="19500000">
            <a:off x="5136634" y="1231528"/>
            <a:ext cx="19346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)</a:t>
            </a:r>
            <a:r>
              <a:rPr lang="en-US" altLang="zh-CN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Tr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3718472" y="1970326"/>
            <a:ext cx="6526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4488036" y="1970326"/>
            <a:ext cx="6526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5257600" y="1970326"/>
            <a:ext cx="6526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5903184" y="235686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5877272" y="1884526"/>
            <a:ext cx="5132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5908387" y="249465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5958080" y="280235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5958080" y="306921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5958080" y="329274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5958080" y="35575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5940054" y="405855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5897981" y="221223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接连接符 91"/>
          <p:cNvCxnSpPr/>
          <p:nvPr/>
        </p:nvCxnSpPr>
        <p:spPr>
          <a:xfrm>
            <a:off x="2663283" y="2219288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>
            <a:off x="2663283" y="2430842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>
            <a:off x="2663283" y="2671688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>
            <a:off x="2663283" y="2959720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>
            <a:off x="2663283" y="3391768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>
            <a:off x="2663283" y="3751808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/>
          <p:cNvCxnSpPr/>
          <p:nvPr/>
        </p:nvCxnSpPr>
        <p:spPr>
          <a:xfrm>
            <a:off x="2663283" y="4111848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图片 5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494082" y="2186630"/>
            <a:ext cx="70267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853" y="2186630"/>
            <a:ext cx="716087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9041" y="2186630"/>
            <a:ext cx="716925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矩形 47"/>
          <p:cNvSpPr/>
          <p:nvPr/>
        </p:nvSpPr>
        <p:spPr>
          <a:xfrm>
            <a:off x="-2695" y="1868804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G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2316512" y="1868804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2053718" y="1850281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1529764" y="1868804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/>
          <p:cNvSpPr/>
          <p:nvPr/>
        </p:nvSpPr>
        <p:spPr>
          <a:xfrm>
            <a:off x="1266970" y="1850281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828144" y="1868804"/>
            <a:ext cx="2888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565350" y="1850281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1"/>
          <p:cNvSpPr txBox="1"/>
          <p:nvPr/>
        </p:nvSpPr>
        <p:spPr>
          <a:xfrm rot="19500000">
            <a:off x="620942" y="1434383"/>
            <a:ext cx="115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rg)</a:t>
            </a:r>
            <a:r>
              <a:rPr lang="en-US" altLang="zh-CN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 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12"/>
          <p:cNvSpPr txBox="1"/>
          <p:nvPr/>
        </p:nvSpPr>
        <p:spPr>
          <a:xfrm rot="19500000">
            <a:off x="1272237" y="1240441"/>
            <a:ext cx="1795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rg)</a:t>
            </a:r>
            <a:r>
              <a:rPr lang="en-US" altLang="zh-CN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W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13"/>
          <p:cNvSpPr txBox="1"/>
          <p:nvPr/>
        </p:nvSpPr>
        <p:spPr>
          <a:xfrm rot="19500000">
            <a:off x="2029756" y="1231528"/>
            <a:ext cx="19346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)</a:t>
            </a:r>
            <a:r>
              <a:rPr lang="en-US" altLang="zh-CN" sz="14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Tr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476430" y="1951608"/>
            <a:ext cx="6526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1245994" y="1951608"/>
            <a:ext cx="6526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2015558" y="1951608"/>
            <a:ext cx="6526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矩形 76"/>
          <p:cNvSpPr/>
          <p:nvPr/>
        </p:nvSpPr>
        <p:spPr>
          <a:xfrm>
            <a:off x="2787493" y="1884526"/>
            <a:ext cx="5132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2789067" y="229478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2789067" y="254879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2789067" y="281564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2789067" y="319973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2789067" y="359881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2783294" y="395526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2793924" y="209688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/>
          <p:cNvSpPr txBox="1"/>
          <p:nvPr/>
        </p:nvSpPr>
        <p:spPr>
          <a:xfrm>
            <a:off x="3337931" y="1225904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857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16</TotalTime>
  <Words>54</Words>
  <Application>Microsoft Office PowerPoint</Application>
  <PresentationFormat>A4 纸张(210x297 毫米)</PresentationFormat>
  <Paragraphs>4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AD</dc:creator>
  <cp:lastModifiedBy>LAD</cp:lastModifiedBy>
  <cp:revision>1512</cp:revision>
  <dcterms:created xsi:type="dcterms:W3CDTF">2017-08-05T06:51:11Z</dcterms:created>
  <dcterms:modified xsi:type="dcterms:W3CDTF">2018-04-22T13:17:59Z</dcterms:modified>
</cp:coreProperties>
</file>